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2121"/>
    <a:srgbClr val="FFFFFF"/>
    <a:srgbClr val="F4A10C"/>
    <a:srgbClr val="CC0066"/>
    <a:srgbClr val="D60093"/>
    <a:srgbClr val="FFD9EC"/>
    <a:srgbClr val="33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70" d="100"/>
          <a:sy n="170" d="100"/>
        </p:scale>
        <p:origin x="32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0CE4C9-DA85-4DAF-AE42-215FEC442188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1964C1-0261-47D1-A217-89B016AAC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6593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13C084-0ED3-B8D0-8887-EF22691809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CEC0EA4C-F384-B56E-D1DA-51E00EDAF1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8490B7-700F-A86E-5A9D-2D5E0A2B3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CB16EAF-9F92-3402-89ED-58077BD17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1056BCD-578C-E8BF-9A6B-954389850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329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68E738-5B15-557B-CFF6-119E3100AD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0CD9BBF-14F1-B524-8193-F11F4B6887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AA904DB-D2CB-318D-F0E1-9C71DE54F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A658A54-5052-7838-D56E-86928CAB1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D7E622-2437-A2D8-1AC1-30666DDB7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242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4A4E7B5-E171-5594-580D-9D78EFD093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5C114CB-1978-32AF-9D16-94645586B5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864660-A013-13E1-7522-507AB25E6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B3BCD0-9B9B-E6A1-728E-1DBDEF14C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30FFB1-3914-C2F3-3029-94AF5BB9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10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0721A0-6B3E-0A93-85AF-C3846DD94F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3D6EA17-A816-EFCD-E07F-38B1CBF59F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B571610-F005-23A9-59E0-8DF4BC997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E998BB9-4562-FE04-4C99-45127F9CD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8DBB402-8DDD-1014-F2F1-202BE552B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6628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C5798B-2221-BC7B-FC47-6B31820DBE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54675CA-792C-E290-7371-2B0350A73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401ECCA-37AF-BB44-F56C-652F05069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F598B7-5681-901D-4A03-C1983BCBB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B5A3B-0168-3BB3-4EDC-09D4CD3FC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5337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B378667-DE6E-0410-D74A-0FAB13F0DC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A3E0B6D-956A-76B6-A7A5-E16222C419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DF2620-F225-653E-4321-4D949A7A06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1646A3-3BEF-5A2F-B591-DF01AE3A2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00FAFAC-93DB-09A3-54E6-DFEC463E1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A8C6F55-5043-A89F-9AAA-81ED94513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243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2CB365-62B3-4B9C-C7ED-9021531AB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CEBEA3C-19DF-3F2A-987E-DBF890128D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48BC2B9-148A-E301-9672-CD5259ED05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ECAB99E-B2EE-4C06-BD22-6D9850B6C1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8C16F60-6F6B-B369-E741-E5448E8B2E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061FFCC8-53A5-A4F3-2191-E6589834D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52C658E-A7B6-DC27-78B8-6257404C5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83FF6FAA-668C-C936-DDA6-8D239EB6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131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FD3F3-B7B4-4E78-7E94-E14A3D5E2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37A1AFE-6D9C-D987-8F1E-F1CC8B314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71D762D-4B63-9EF7-06D8-351EAD01A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632F694-06B6-47D0-1E92-F99DEA80A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4662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80C6E7A-16E9-6CBD-8D92-0C2BCA732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3CB15681-6354-1DA8-5DD7-41F4B0EFD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D948356-9EFD-95B7-2AF6-3DCF62F46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1683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37D832-9C7F-E673-3ABF-68B1C512D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87992B9-6E00-0C30-341F-7BDD596F7B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43A142C-2B07-31C1-C075-65B3B38B47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6E87FFC-FDEC-D9BC-0187-83AD041F0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20A8DFD-4028-5F79-33A5-021991D2E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384B9DC-FA13-6D32-BD2B-4D1F13D9F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3156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DC2873-2FE2-7243-7258-89B919381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8486321-8CCE-12C8-4431-580FDDB8C7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333D718-39BB-2424-4B5D-41209DCEA6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C1BEF9D-8293-387B-8379-3224B1DA1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EB4DC59-BB59-47CD-54E5-CB658124AC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BEA8838-1944-641B-7CC5-E5746DC52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6085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08BE9E15-0186-D854-0A9A-B67866CB0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EAE3223-2D1E-0573-77BE-5384C5C61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1A2674F-F75C-13D1-F308-5496F6805D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F45163-F3CC-44F0-A6CF-333ECBA2EE6E}" type="datetimeFigureOut">
              <a:rPr lang="fr-FR" smtClean="0"/>
              <a:t>18/07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677402F-1B00-21C4-C733-03613F9B43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6F70A26-6C1C-8515-3840-3B24C82103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71B4E-57FB-4F4E-84E8-C5687AB6150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848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75BF789A-B535-759B-8C89-B4B28A92F844}"/>
              </a:ext>
            </a:extLst>
          </p:cNvPr>
          <p:cNvSpPr txBox="1"/>
          <p:nvPr/>
        </p:nvSpPr>
        <p:spPr>
          <a:xfrm>
            <a:off x="196670" y="5290796"/>
            <a:ext cx="38799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trategy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0E79050-E3E1-FBDC-9C4F-9349BD9B816F}"/>
              </a:ext>
            </a:extLst>
          </p:cNvPr>
          <p:cNvSpPr txBox="1"/>
          <p:nvPr/>
        </p:nvSpPr>
        <p:spPr>
          <a:xfrm>
            <a:off x="288106" y="4750417"/>
            <a:ext cx="619478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andidate miRNA biomarkers with a potential prognostic effect on overall survival (p&lt;0.2), using Cox models with Bonferroni-Holm correction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288AE534-5192-4FCF-BB96-AA90E5E121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928" y="492065"/>
            <a:ext cx="6100651" cy="388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519461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9</TotalTime>
  <Words>29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enaelle Levallet</dc:creator>
  <cp:lastModifiedBy>Jerôme Levallet</cp:lastModifiedBy>
  <cp:revision>54</cp:revision>
  <dcterms:created xsi:type="dcterms:W3CDTF">2022-05-08T15:12:19Z</dcterms:created>
  <dcterms:modified xsi:type="dcterms:W3CDTF">2025-07-18T09:32:30Z</dcterms:modified>
</cp:coreProperties>
</file>